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9" r:id="rId4"/>
    <p:sldId id="258" r:id="rId5"/>
  </p:sldIdLst>
  <p:sldSz cx="9601200" cy="12801600" type="A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9A7D13-05FC-4DE1-AB8A-86AE99A6C4CF}" v="28" dt="2024-05-20T13:13:34.1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5" autoAdjust="0"/>
    <p:restoredTop sz="94660"/>
  </p:normalViewPr>
  <p:slideViewPr>
    <p:cSldViewPr snapToGrid="0">
      <p:cViewPr>
        <p:scale>
          <a:sx n="75" d="100"/>
          <a:sy n="75" d="100"/>
        </p:scale>
        <p:origin x="22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nii Harte" userId="dbd9ac18-7160-4d40-9ccb-1e3f00c2f233" providerId="ADAL" clId="{919A7D13-05FC-4DE1-AB8A-86AE99A6C4CF}"/>
    <pc:docChg chg="undo redo custSel addSld modSld sldOrd">
      <pc:chgData name="Dannii Harte" userId="dbd9ac18-7160-4d40-9ccb-1e3f00c2f233" providerId="ADAL" clId="{919A7D13-05FC-4DE1-AB8A-86AE99A6C4CF}" dt="2024-05-20T13:15:07.660" v="339" actId="121"/>
      <pc:docMkLst>
        <pc:docMk/>
      </pc:docMkLst>
      <pc:sldChg chg="modSp mod ord">
        <pc:chgData name="Dannii Harte" userId="dbd9ac18-7160-4d40-9ccb-1e3f00c2f233" providerId="ADAL" clId="{919A7D13-05FC-4DE1-AB8A-86AE99A6C4CF}" dt="2024-05-20T08:36:35.531" v="62"/>
        <pc:sldMkLst>
          <pc:docMk/>
          <pc:sldMk cId="1709954447" sldId="258"/>
        </pc:sldMkLst>
        <pc:spChg chg="mod">
          <ac:chgData name="Dannii Harte" userId="dbd9ac18-7160-4d40-9ccb-1e3f00c2f233" providerId="ADAL" clId="{919A7D13-05FC-4DE1-AB8A-86AE99A6C4CF}" dt="2024-05-20T08:33:12.241" v="58" actId="20577"/>
          <ac:spMkLst>
            <pc:docMk/>
            <pc:sldMk cId="1709954447" sldId="258"/>
            <ac:spMk id="5" creationId="{9A00BC54-8F03-E296-BCDB-86D10FE4A0FA}"/>
          </ac:spMkLst>
        </pc:spChg>
      </pc:sldChg>
      <pc:sldChg chg="addSp delSp modSp mod">
        <pc:chgData name="Dannii Harte" userId="dbd9ac18-7160-4d40-9ccb-1e3f00c2f233" providerId="ADAL" clId="{919A7D13-05FC-4DE1-AB8A-86AE99A6C4CF}" dt="2024-05-20T13:15:07.660" v="339" actId="121"/>
        <pc:sldMkLst>
          <pc:docMk/>
          <pc:sldMk cId="1878967792" sldId="259"/>
        </pc:sldMkLst>
        <pc:spChg chg="mod">
          <ac:chgData name="Dannii Harte" userId="dbd9ac18-7160-4d40-9ccb-1e3f00c2f233" providerId="ADAL" clId="{919A7D13-05FC-4DE1-AB8A-86AE99A6C4CF}" dt="2024-05-20T08:33:18.374" v="60" actId="20577"/>
          <ac:spMkLst>
            <pc:docMk/>
            <pc:sldMk cId="1878967792" sldId="259"/>
            <ac:spMk id="3" creationId="{760B9A92-7982-E2C9-BC1C-A1EB2F34D565}"/>
          </ac:spMkLst>
        </pc:spChg>
        <pc:graphicFrameChg chg="del mod">
          <ac:chgData name="Dannii Harte" userId="dbd9ac18-7160-4d40-9ccb-1e3f00c2f233" providerId="ADAL" clId="{919A7D13-05FC-4DE1-AB8A-86AE99A6C4CF}" dt="2024-05-20T13:06:53.210" v="292" actId="478"/>
          <ac:graphicFrameMkLst>
            <pc:docMk/>
            <pc:sldMk cId="1878967792" sldId="259"/>
            <ac:graphicFrameMk id="2" creationId="{6CF3CFD6-E4A6-D127-78EE-253BF20BBB49}"/>
          </ac:graphicFrameMkLst>
        </pc:graphicFrameChg>
        <pc:graphicFrameChg chg="add mod modGraphic">
          <ac:chgData name="Dannii Harte" userId="dbd9ac18-7160-4d40-9ccb-1e3f00c2f233" providerId="ADAL" clId="{919A7D13-05FC-4DE1-AB8A-86AE99A6C4CF}" dt="2024-05-20T13:15:07.660" v="339" actId="121"/>
          <ac:graphicFrameMkLst>
            <pc:docMk/>
            <pc:sldMk cId="1878967792" sldId="259"/>
            <ac:graphicFrameMk id="4" creationId="{D8387922-818A-55C1-726C-B3311AC46819}"/>
          </ac:graphicFrameMkLst>
        </pc:graphicFrameChg>
      </pc:sldChg>
      <pc:sldChg chg="addSp modSp new mod ord">
        <pc:chgData name="Dannii Harte" userId="dbd9ac18-7160-4d40-9ccb-1e3f00c2f233" providerId="ADAL" clId="{919A7D13-05FC-4DE1-AB8A-86AE99A6C4CF}" dt="2024-05-20T09:07:33.182" v="217" actId="20577"/>
        <pc:sldMkLst>
          <pc:docMk/>
          <pc:sldMk cId="2157034702" sldId="260"/>
        </pc:sldMkLst>
        <pc:spChg chg="add mod">
          <ac:chgData name="Dannii Harte" userId="dbd9ac18-7160-4d40-9ccb-1e3f00c2f233" providerId="ADAL" clId="{919A7D13-05FC-4DE1-AB8A-86AE99A6C4CF}" dt="2024-05-20T09:03:06.518" v="184" actId="20577"/>
          <ac:spMkLst>
            <pc:docMk/>
            <pc:sldMk cId="2157034702" sldId="260"/>
            <ac:spMk id="3" creationId="{97A2CEFF-A210-323A-93A3-7CEE4B0132E3}"/>
          </ac:spMkLst>
        </pc:spChg>
        <pc:graphicFrameChg chg="add mod modGraphic">
          <ac:chgData name="Dannii Harte" userId="dbd9ac18-7160-4d40-9ccb-1e3f00c2f233" providerId="ADAL" clId="{919A7D13-05FC-4DE1-AB8A-86AE99A6C4CF}" dt="2024-05-20T09:07:33.182" v="217" actId="20577"/>
          <ac:graphicFrameMkLst>
            <pc:docMk/>
            <pc:sldMk cId="2157034702" sldId="260"/>
            <ac:graphicFrameMk id="2" creationId="{47B433A0-933A-E59F-74C1-80621969BC42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208CE-F772-6393-D69F-5FD3A2F376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00150" y="2095078"/>
            <a:ext cx="7200900" cy="4456853"/>
          </a:xfrm>
        </p:spPr>
        <p:txBody>
          <a:bodyPr anchor="b"/>
          <a:lstStyle>
            <a:lvl1pPr algn="ctr">
              <a:defRPr sz="11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B4984B-AEBA-38DD-1502-38FBA4E818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4480"/>
            </a:lvl1pPr>
            <a:lvl2pPr marL="853455" indent="0" algn="ctr">
              <a:buNone/>
              <a:defRPr sz="3733"/>
            </a:lvl2pPr>
            <a:lvl3pPr marL="1706910" indent="0" algn="ctr">
              <a:buNone/>
              <a:defRPr sz="3360"/>
            </a:lvl3pPr>
            <a:lvl4pPr marL="2560366" indent="0" algn="ctr">
              <a:buNone/>
              <a:defRPr sz="2987"/>
            </a:lvl4pPr>
            <a:lvl5pPr marL="3413821" indent="0" algn="ctr">
              <a:buNone/>
              <a:defRPr sz="2987"/>
            </a:lvl5pPr>
            <a:lvl6pPr marL="4267276" indent="0" algn="ctr">
              <a:buNone/>
              <a:defRPr sz="2987"/>
            </a:lvl6pPr>
            <a:lvl7pPr marL="5120731" indent="0" algn="ctr">
              <a:buNone/>
              <a:defRPr sz="2987"/>
            </a:lvl7pPr>
            <a:lvl8pPr marL="5974187" indent="0" algn="ctr">
              <a:buNone/>
              <a:defRPr sz="2987"/>
            </a:lvl8pPr>
            <a:lvl9pPr marL="6827642" indent="0" algn="ctr">
              <a:buNone/>
              <a:defRPr sz="2987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F6A4AE-3E9C-6694-22A0-75527BCB1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415C83-4301-3EA7-5EC9-1879A929E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EF6676-1969-5B26-CA39-1758FFC7F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4714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5F7B08-0184-C7B1-E2D4-ECD9E4D9EA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B64CA6-C63F-B762-2A02-3BDA5E3EDA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15DAC7-E96B-1D20-FA15-79F9E2978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001406-C3B6-ACB3-4F35-BE6E9F55D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9083A5-248C-E56B-4D18-9C3A0B036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7596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CC6768-BC78-0DA8-F59C-78FECCD5AA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000432-CB90-809D-D2E8-FBB7077598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DF1A08-4513-8B03-AE5A-3353A6671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5BD25E-DBB9-B14E-6E30-9B9A5FE2F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CC152D-C5AD-ABE3-8174-E3FFB4677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725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E955E-9480-7F6D-2A70-F54F8E4CF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8E372E-6858-80B2-399E-1755EE1949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DB49E-6549-8219-0062-A870338C2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5BFCB-CD9F-F619-D8FC-F94EF7FAE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E08A76-3B46-7FD2-D7B0-3B0B79F8F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75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134305-0EB1-A63B-0943-5C1A5A278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5082" y="3191512"/>
            <a:ext cx="8281035" cy="5325109"/>
          </a:xfrm>
        </p:spPr>
        <p:txBody>
          <a:bodyPr anchor="b"/>
          <a:lstStyle>
            <a:lvl1pPr>
              <a:defRPr sz="11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97CC08-A40F-2F1F-5E21-4C5741CBFC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55082" y="8566999"/>
            <a:ext cx="8281035" cy="2800349"/>
          </a:xfrm>
        </p:spPr>
        <p:txBody>
          <a:bodyPr/>
          <a:lstStyle>
            <a:lvl1pPr marL="0" indent="0">
              <a:buNone/>
              <a:defRPr sz="4480">
                <a:solidFill>
                  <a:schemeClr val="tx1">
                    <a:tint val="75000"/>
                  </a:schemeClr>
                </a:solidFill>
              </a:defRPr>
            </a:lvl1pPr>
            <a:lvl2pPr marL="853455" indent="0">
              <a:buNone/>
              <a:defRPr sz="3733">
                <a:solidFill>
                  <a:schemeClr val="tx1">
                    <a:tint val="75000"/>
                  </a:schemeClr>
                </a:solidFill>
              </a:defRPr>
            </a:lvl2pPr>
            <a:lvl3pPr marL="170691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3pPr>
            <a:lvl4pPr marL="2560366" indent="0">
              <a:buNone/>
              <a:defRPr sz="2987">
                <a:solidFill>
                  <a:schemeClr val="tx1">
                    <a:tint val="75000"/>
                  </a:schemeClr>
                </a:solidFill>
              </a:defRPr>
            </a:lvl4pPr>
            <a:lvl5pPr marL="3413821" indent="0">
              <a:buNone/>
              <a:defRPr sz="2987">
                <a:solidFill>
                  <a:schemeClr val="tx1">
                    <a:tint val="75000"/>
                  </a:schemeClr>
                </a:solidFill>
              </a:defRPr>
            </a:lvl5pPr>
            <a:lvl6pPr marL="4267276" indent="0">
              <a:buNone/>
              <a:defRPr sz="2987">
                <a:solidFill>
                  <a:schemeClr val="tx1">
                    <a:tint val="75000"/>
                  </a:schemeClr>
                </a:solidFill>
              </a:defRPr>
            </a:lvl6pPr>
            <a:lvl7pPr marL="5120731" indent="0">
              <a:buNone/>
              <a:defRPr sz="2987">
                <a:solidFill>
                  <a:schemeClr val="tx1">
                    <a:tint val="75000"/>
                  </a:schemeClr>
                </a:solidFill>
              </a:defRPr>
            </a:lvl7pPr>
            <a:lvl8pPr marL="5974187" indent="0">
              <a:buNone/>
              <a:defRPr sz="2987">
                <a:solidFill>
                  <a:schemeClr val="tx1">
                    <a:tint val="75000"/>
                  </a:schemeClr>
                </a:solidFill>
              </a:defRPr>
            </a:lvl8pPr>
            <a:lvl9pPr marL="6827642" indent="0">
              <a:buNone/>
              <a:defRPr sz="298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73D4D8-FCD7-6C6F-055C-8A567148E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DE50C-33B8-3B27-5E9C-B85107AB6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11C8FA-F9E0-F392-167B-E126015A4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3592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7C90EB-D3B8-E7EC-30E2-830663C81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4748E7-6A43-1ABA-DD83-F609F48EB3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21DB31-066E-F189-8A9C-295C24B260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3C4D55-6F88-78E1-E6C2-6B41DCB07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266DE4-D372-0052-8C4A-43DB41C2E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D1C2D6-2F1E-E267-7084-D092E1473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578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8778F4-5175-0DA7-7ED8-9E06755BC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1333" y="681568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C649C9-6719-531B-7F68-D3CD8BE72A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4480" b="1"/>
            </a:lvl1pPr>
            <a:lvl2pPr marL="853455" indent="0">
              <a:buNone/>
              <a:defRPr sz="3733" b="1"/>
            </a:lvl2pPr>
            <a:lvl3pPr marL="1706910" indent="0">
              <a:buNone/>
              <a:defRPr sz="3360" b="1"/>
            </a:lvl3pPr>
            <a:lvl4pPr marL="2560366" indent="0">
              <a:buNone/>
              <a:defRPr sz="2987" b="1"/>
            </a:lvl4pPr>
            <a:lvl5pPr marL="3413821" indent="0">
              <a:buNone/>
              <a:defRPr sz="2987" b="1"/>
            </a:lvl5pPr>
            <a:lvl6pPr marL="4267276" indent="0">
              <a:buNone/>
              <a:defRPr sz="2987" b="1"/>
            </a:lvl6pPr>
            <a:lvl7pPr marL="5120731" indent="0">
              <a:buNone/>
              <a:defRPr sz="2987" b="1"/>
            </a:lvl7pPr>
            <a:lvl8pPr marL="5974187" indent="0">
              <a:buNone/>
              <a:defRPr sz="2987" b="1"/>
            </a:lvl8pPr>
            <a:lvl9pPr marL="6827642" indent="0">
              <a:buNone/>
              <a:defRPr sz="29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848DE8-3146-B668-3D8F-305A4BF621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1CED2D-74E5-9304-B760-F5AE189C48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860607" y="3138171"/>
            <a:ext cx="4081761" cy="1537969"/>
          </a:xfrm>
        </p:spPr>
        <p:txBody>
          <a:bodyPr anchor="b"/>
          <a:lstStyle>
            <a:lvl1pPr marL="0" indent="0">
              <a:buNone/>
              <a:defRPr sz="4480" b="1"/>
            </a:lvl1pPr>
            <a:lvl2pPr marL="853455" indent="0">
              <a:buNone/>
              <a:defRPr sz="3733" b="1"/>
            </a:lvl2pPr>
            <a:lvl3pPr marL="1706910" indent="0">
              <a:buNone/>
              <a:defRPr sz="3360" b="1"/>
            </a:lvl3pPr>
            <a:lvl4pPr marL="2560366" indent="0">
              <a:buNone/>
              <a:defRPr sz="2987" b="1"/>
            </a:lvl4pPr>
            <a:lvl5pPr marL="3413821" indent="0">
              <a:buNone/>
              <a:defRPr sz="2987" b="1"/>
            </a:lvl5pPr>
            <a:lvl6pPr marL="4267276" indent="0">
              <a:buNone/>
              <a:defRPr sz="2987" b="1"/>
            </a:lvl6pPr>
            <a:lvl7pPr marL="5120731" indent="0">
              <a:buNone/>
              <a:defRPr sz="2987" b="1"/>
            </a:lvl7pPr>
            <a:lvl8pPr marL="5974187" indent="0">
              <a:buNone/>
              <a:defRPr sz="2987" b="1"/>
            </a:lvl8pPr>
            <a:lvl9pPr marL="6827642" indent="0">
              <a:buNone/>
              <a:defRPr sz="29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834ACB-6FCC-AADE-D23C-79003770BE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860607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EAC78F-0B72-F360-C888-B7787F859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83DBAE-1F02-D5C1-EB51-FA1D5A21C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B0C0C2-867A-2362-10CD-F5F3510D4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540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00C25-E1C3-C781-FC66-B6AA0DA41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8DE8A1-C6CB-78B4-D959-550781047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4216692-FD89-4E9F-53C1-5D5B50DC6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302C537-3FB3-B7E8-AA8F-4A0504122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678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A29B55-E22A-4FB7-CD66-2D615EB82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CBB8FE-D9F9-CED2-8F2F-0E1CE4B30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A9AB34-E21B-B695-665A-F75761150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9782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FBD00-929F-9745-FF43-173A2CDD9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5973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67DC1F-0A77-69F8-866F-9195636FB7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081760" y="1843194"/>
            <a:ext cx="4860608" cy="9097433"/>
          </a:xfrm>
        </p:spPr>
        <p:txBody>
          <a:bodyPr/>
          <a:lstStyle>
            <a:lvl1pPr>
              <a:defRPr sz="5973"/>
            </a:lvl1pPr>
            <a:lvl2pPr>
              <a:defRPr sz="5227"/>
            </a:lvl2pPr>
            <a:lvl3pPr>
              <a:defRPr sz="4480"/>
            </a:lvl3pPr>
            <a:lvl4pPr>
              <a:defRPr sz="3733"/>
            </a:lvl4pPr>
            <a:lvl5pPr>
              <a:defRPr sz="3733"/>
            </a:lvl5pPr>
            <a:lvl6pPr>
              <a:defRPr sz="3733"/>
            </a:lvl6pPr>
            <a:lvl7pPr>
              <a:defRPr sz="3733"/>
            </a:lvl7pPr>
            <a:lvl8pPr>
              <a:defRPr sz="3733"/>
            </a:lvl8pPr>
            <a:lvl9pPr>
              <a:defRPr sz="37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8F1BFA-603C-8F8A-A6CF-115991D16E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2987"/>
            </a:lvl1pPr>
            <a:lvl2pPr marL="853455" indent="0">
              <a:buNone/>
              <a:defRPr sz="2613"/>
            </a:lvl2pPr>
            <a:lvl3pPr marL="1706910" indent="0">
              <a:buNone/>
              <a:defRPr sz="2240"/>
            </a:lvl3pPr>
            <a:lvl4pPr marL="2560366" indent="0">
              <a:buNone/>
              <a:defRPr sz="1867"/>
            </a:lvl4pPr>
            <a:lvl5pPr marL="3413821" indent="0">
              <a:buNone/>
              <a:defRPr sz="1867"/>
            </a:lvl5pPr>
            <a:lvl6pPr marL="4267276" indent="0">
              <a:buNone/>
              <a:defRPr sz="1867"/>
            </a:lvl6pPr>
            <a:lvl7pPr marL="5120731" indent="0">
              <a:buNone/>
              <a:defRPr sz="1867"/>
            </a:lvl7pPr>
            <a:lvl8pPr marL="5974187" indent="0">
              <a:buNone/>
              <a:defRPr sz="1867"/>
            </a:lvl8pPr>
            <a:lvl9pPr marL="6827642" indent="0">
              <a:buNone/>
              <a:defRPr sz="1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9DA3B6-2F87-2208-D099-E9BE31109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E5164B-3686-6B3A-E28C-32DFC8C9A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F0AC64-E191-76E6-BC8F-687366E03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5791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CF8177-B880-F20A-BB25-0D8B50D4F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5973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AF4090-E4FB-93ED-A6E9-CCC92E5A60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081760" y="1843194"/>
            <a:ext cx="4860608" cy="9097433"/>
          </a:xfrm>
        </p:spPr>
        <p:txBody>
          <a:bodyPr/>
          <a:lstStyle>
            <a:lvl1pPr marL="0" indent="0">
              <a:buNone/>
              <a:defRPr sz="5973"/>
            </a:lvl1pPr>
            <a:lvl2pPr marL="853455" indent="0">
              <a:buNone/>
              <a:defRPr sz="5227"/>
            </a:lvl2pPr>
            <a:lvl3pPr marL="1706910" indent="0">
              <a:buNone/>
              <a:defRPr sz="4480"/>
            </a:lvl3pPr>
            <a:lvl4pPr marL="2560366" indent="0">
              <a:buNone/>
              <a:defRPr sz="3733"/>
            </a:lvl4pPr>
            <a:lvl5pPr marL="3413821" indent="0">
              <a:buNone/>
              <a:defRPr sz="3733"/>
            </a:lvl5pPr>
            <a:lvl6pPr marL="4267276" indent="0">
              <a:buNone/>
              <a:defRPr sz="3733"/>
            </a:lvl6pPr>
            <a:lvl7pPr marL="5120731" indent="0">
              <a:buNone/>
              <a:defRPr sz="3733"/>
            </a:lvl7pPr>
            <a:lvl8pPr marL="5974187" indent="0">
              <a:buNone/>
              <a:defRPr sz="3733"/>
            </a:lvl8pPr>
            <a:lvl9pPr marL="6827642" indent="0">
              <a:buNone/>
              <a:defRPr sz="3733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FB3580-318F-ABCD-544D-5CC2FB9D7B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2987"/>
            </a:lvl1pPr>
            <a:lvl2pPr marL="853455" indent="0">
              <a:buNone/>
              <a:defRPr sz="2613"/>
            </a:lvl2pPr>
            <a:lvl3pPr marL="1706910" indent="0">
              <a:buNone/>
              <a:defRPr sz="2240"/>
            </a:lvl3pPr>
            <a:lvl4pPr marL="2560366" indent="0">
              <a:buNone/>
              <a:defRPr sz="1867"/>
            </a:lvl4pPr>
            <a:lvl5pPr marL="3413821" indent="0">
              <a:buNone/>
              <a:defRPr sz="1867"/>
            </a:lvl5pPr>
            <a:lvl6pPr marL="4267276" indent="0">
              <a:buNone/>
              <a:defRPr sz="1867"/>
            </a:lvl6pPr>
            <a:lvl7pPr marL="5120731" indent="0">
              <a:buNone/>
              <a:defRPr sz="1867"/>
            </a:lvl7pPr>
            <a:lvl8pPr marL="5974187" indent="0">
              <a:buNone/>
              <a:defRPr sz="1867"/>
            </a:lvl8pPr>
            <a:lvl9pPr marL="6827642" indent="0">
              <a:buNone/>
              <a:defRPr sz="1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CEB4F-46DA-C1DF-73BE-D2AA294A4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BD5517-3770-09AA-9C69-152E8151C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F92505-D7E9-8EA3-BBE8-7701E8A98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2156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ED773E-D9BC-1B00-9477-556A0CD26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0083" y="681568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1281B9-2572-8D56-45A3-DDB120895E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26A4E8-4880-198D-6EB6-132C0FD01A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60083" y="11865187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B634A-9D5B-4B7B-ADCD-5F0AD87C2EB1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1E51DC-F5F5-83E4-B256-F837DB845E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80398" y="11865187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0176CA-DF12-78B0-F4F8-5EB241901E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780848" y="11865187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3BD2D-8821-4C70-9028-FB7CA2663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4198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706910" rtl="0" eaLnBrk="1" latinLnBrk="0" hangingPunct="1">
        <a:lnSpc>
          <a:spcPct val="90000"/>
        </a:lnSpc>
        <a:spcBef>
          <a:spcPct val="0"/>
        </a:spcBef>
        <a:buNone/>
        <a:defRPr sz="82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6728" indent="-426728" algn="l" defTabSz="1706910" rtl="0" eaLnBrk="1" latinLnBrk="0" hangingPunct="1">
        <a:lnSpc>
          <a:spcPct val="90000"/>
        </a:lnSpc>
        <a:spcBef>
          <a:spcPts val="1867"/>
        </a:spcBef>
        <a:buFont typeface="Arial" panose="020B0604020202020204" pitchFamily="34" charset="0"/>
        <a:buChar char="•"/>
        <a:defRPr sz="5227" kern="1200">
          <a:solidFill>
            <a:schemeClr val="tx1"/>
          </a:solidFill>
          <a:latin typeface="+mn-lt"/>
          <a:ea typeface="+mn-ea"/>
          <a:cs typeface="+mn-cs"/>
        </a:defRPr>
      </a:lvl1pPr>
      <a:lvl2pPr marL="1280183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2pPr>
      <a:lvl3pPr marL="2133638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3pPr>
      <a:lvl4pPr marL="2987093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4pPr>
      <a:lvl5pPr marL="3840549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5pPr>
      <a:lvl6pPr marL="4694004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6pPr>
      <a:lvl7pPr marL="5547459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7pPr>
      <a:lvl8pPr marL="6400914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8pPr>
      <a:lvl9pPr marL="7254370" indent="-426728" algn="l" defTabSz="1706910" rtl="0" eaLnBrk="1" latinLnBrk="0" hangingPunct="1">
        <a:lnSpc>
          <a:spcPct val="90000"/>
        </a:lnSpc>
        <a:spcBef>
          <a:spcPts val="933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53455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706910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66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4pPr>
      <a:lvl5pPr marL="3413821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5pPr>
      <a:lvl6pPr marL="4267276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6pPr>
      <a:lvl7pPr marL="5120731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7pPr>
      <a:lvl8pPr marL="5974187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8pPr>
      <a:lvl9pPr marL="6827642" algn="l" defTabSz="1706910" rtl="0" eaLnBrk="1" latinLnBrk="0" hangingPunct="1">
        <a:defRPr sz="33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47B433A0-933A-E59F-74C1-80621969BC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0508368"/>
              </p:ext>
            </p:extLst>
          </p:nvPr>
        </p:nvGraphicFramePr>
        <p:xfrm>
          <a:off x="-1" y="609600"/>
          <a:ext cx="9601200" cy="862148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400300">
                  <a:extLst>
                    <a:ext uri="{9D8B030D-6E8A-4147-A177-3AD203B41FA5}">
                      <a16:colId xmlns:a16="http://schemas.microsoft.com/office/drawing/2014/main" val="1797151865"/>
                    </a:ext>
                  </a:extLst>
                </a:gridCol>
                <a:gridCol w="2400300">
                  <a:extLst>
                    <a:ext uri="{9D8B030D-6E8A-4147-A177-3AD203B41FA5}">
                      <a16:colId xmlns:a16="http://schemas.microsoft.com/office/drawing/2014/main" val="311218043"/>
                    </a:ext>
                  </a:extLst>
                </a:gridCol>
                <a:gridCol w="2400300">
                  <a:extLst>
                    <a:ext uri="{9D8B030D-6E8A-4147-A177-3AD203B41FA5}">
                      <a16:colId xmlns:a16="http://schemas.microsoft.com/office/drawing/2014/main" val="917989394"/>
                    </a:ext>
                  </a:extLst>
                </a:gridCol>
                <a:gridCol w="2400300">
                  <a:extLst>
                    <a:ext uri="{9D8B030D-6E8A-4147-A177-3AD203B41FA5}">
                      <a16:colId xmlns:a16="http://schemas.microsoft.com/office/drawing/2014/main" val="4195773247"/>
                    </a:ext>
                  </a:extLst>
                </a:gridCol>
              </a:tblGrid>
              <a:tr h="686462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Endpoint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F value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 err="1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Pr</a:t>
                      </a:r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(&gt;F)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890313577"/>
                  </a:ext>
                </a:extLst>
              </a:tr>
              <a:tr h="492408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26 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5811417"/>
                  </a:ext>
                </a:extLst>
              </a:tr>
              <a:tr h="492408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2/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6289533"/>
                  </a:ext>
                </a:extLst>
              </a:tr>
              <a:tr h="520058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2887336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43 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4151353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2AX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0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2 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99488300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12 *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61550435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M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35 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4269144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4 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4202501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2/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06263402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5 *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25062991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79 *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8923701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2AX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38188504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4e-06 **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31155066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5 *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62168572"/>
                  </a:ext>
                </a:extLst>
              </a:tr>
              <a:tr h="717703">
                <a:tc gridSpan="4">
                  <a:txBody>
                    <a:bodyPr/>
                    <a:lstStyle/>
                    <a:p>
                      <a:r>
                        <a:rPr lang="fr-FR" sz="2800" baseline="30000" dirty="0"/>
                        <a:t>Signifiance (P ≤ 0.05). codes:  0.0001 ‘***’, 0.001 ‘**’, 0.01 ‘*’.</a:t>
                      </a:r>
                      <a:endParaRPr lang="en-GB" sz="2800" baseline="30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2400" baseline="30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976567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7A2CEFF-A210-323A-93A3-7CEE4B0132E3}"/>
              </a:ext>
            </a:extLst>
          </p:cNvPr>
          <p:cNvSpPr txBox="1"/>
          <p:nvPr/>
        </p:nvSpPr>
        <p:spPr>
          <a:xfrm>
            <a:off x="0" y="97397"/>
            <a:ext cx="9601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Table 1: One-way ANOVA outcomes for all seven endpoints of the chemicals MMS and carbendazim. </a:t>
            </a:r>
          </a:p>
        </p:txBody>
      </p:sp>
    </p:spTree>
    <p:extLst>
      <p:ext uri="{BB962C8B-B14F-4D97-AF65-F5344CB8AC3E}">
        <p14:creationId xmlns:p14="http://schemas.microsoft.com/office/powerpoint/2010/main" val="2157034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632346" y="5676380"/>
            <a:ext cx="8550862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>
                <a:latin typeface="Arial Narrow"/>
                <a:cs typeface="Arial Narrow"/>
              </a:rPr>
              <a:t>Supplementary Figure 1 </a:t>
            </a:r>
            <a:r>
              <a:rPr lang="mr-IN" sz="1800" b="1" dirty="0">
                <a:latin typeface="Arial Narrow"/>
                <a:cs typeface="Arial Narrow"/>
              </a:rPr>
              <a:t>–</a:t>
            </a:r>
            <a:r>
              <a:rPr lang="en-US" sz="1800" b="1" dirty="0">
                <a:latin typeface="Arial Narrow"/>
                <a:cs typeface="Arial Narrow"/>
              </a:rPr>
              <a:t> Quantitative comparison of micronucleus dose-response relationships for carbendazim scored manually or by ImageStream flow-cytometry. </a:t>
            </a:r>
            <a:r>
              <a:rPr lang="en-US" sz="1800" dirty="0">
                <a:latin typeface="Arial Narrow"/>
                <a:cs typeface="Arial Narrow"/>
              </a:rPr>
              <a:t>(a) Covariate benchmark dose modeling using dose-response data from either manually-scored slides (red) or by automated ISMN analysis (black). Whereas the dose-response information collected automatically by the ISMN approach underestimates the results of manual scoring, the difference is reasonably consistent. This is reflected in the benchmark dose estimates: the horizontal and vertical dashed lines represent interpolation of the dose-response relationships to determine the equipotent, benchmark dose for a benchmark response size of 100%. Regardless of manual or automated scoring by ISMN, the estimated benchmark dose (BMD</a:t>
            </a:r>
            <a:r>
              <a:rPr lang="en-US" sz="1800" baseline="-25000" dirty="0">
                <a:latin typeface="Arial Narrow"/>
                <a:cs typeface="Arial Narrow"/>
              </a:rPr>
              <a:t>100</a:t>
            </a:r>
            <a:r>
              <a:rPr lang="en-US" sz="1800" dirty="0">
                <a:latin typeface="Arial Narrow"/>
                <a:cs typeface="Arial Narrow"/>
              </a:rPr>
              <a:t>) values are very similar. Panel (b) shows the Individual, exponential model fits to the dose-response data for each method.  </a:t>
            </a:r>
          </a:p>
          <a:p>
            <a:endParaRPr lang="en-US" sz="1800" b="1" dirty="0">
              <a:latin typeface="Arial Narrow"/>
              <a:cs typeface="Arial Narrow"/>
            </a:endParaRPr>
          </a:p>
          <a:p>
            <a:r>
              <a:rPr lang="en-US" sz="1800" b="1" dirty="0">
                <a:latin typeface="Arial Narrow"/>
                <a:cs typeface="Arial Narrow"/>
              </a:rPr>
              <a:t> 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126897" y="842872"/>
            <a:ext cx="9310743" cy="4685332"/>
            <a:chOff x="126897" y="842872"/>
            <a:chExt cx="9310743" cy="4685332"/>
          </a:xfrm>
        </p:grpSpPr>
        <p:grpSp>
          <p:nvGrpSpPr>
            <p:cNvPr id="16" name="Group 15"/>
            <p:cNvGrpSpPr/>
            <p:nvPr/>
          </p:nvGrpSpPr>
          <p:grpSpPr>
            <a:xfrm>
              <a:off x="126897" y="842872"/>
              <a:ext cx="9310743" cy="4685332"/>
              <a:chOff x="126897" y="842872"/>
              <a:chExt cx="9310743" cy="4685332"/>
            </a:xfrm>
          </p:grpSpPr>
          <p:pic>
            <p:nvPicPr>
              <p:cNvPr id="4" name="Picture 3" descr="4_analysis_edit_for_Figure.pn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897" y="1036588"/>
                <a:ext cx="4886710" cy="4484914"/>
              </a:xfrm>
              <a:prstGeom prst="rect">
                <a:avLst/>
              </a:prstGeom>
            </p:spPr>
          </p:pic>
          <p:pic>
            <p:nvPicPr>
              <p:cNvPr id="6" name="Picture 5" descr="fits_for_figure.png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712"/>
              <a:stretch/>
            </p:blipFill>
            <p:spPr>
              <a:xfrm>
                <a:off x="5524604" y="842872"/>
                <a:ext cx="3913036" cy="4458193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5871308" y="5189650"/>
                <a:ext cx="34429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/>
                    <a:cs typeface="Arial"/>
                  </a:rPr>
                  <a:t>log10 dose of carbendazim (ug.mL)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3416805" y="2943840"/>
                <a:ext cx="4153062" cy="3385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>
                    <a:latin typeface="Arial"/>
                    <a:cs typeface="Arial"/>
                  </a:rPr>
                  <a:t>log10 response (% MN)</a:t>
                </a:r>
              </a:p>
            </p:txBody>
          </p:sp>
          <p:cxnSp>
            <p:nvCxnSpPr>
              <p:cNvPr id="10" name="Straight Connector 9"/>
              <p:cNvCxnSpPr/>
              <p:nvPr/>
            </p:nvCxnSpPr>
            <p:spPr>
              <a:xfrm>
                <a:off x="5140602" y="1036588"/>
                <a:ext cx="0" cy="449161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399529" y="842872"/>
                <a:ext cx="80428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A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545770" y="867422"/>
                <a:ext cx="80428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B</a:t>
                </a: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1919014" y="4385700"/>
              <a:ext cx="20022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rgbClr val="FF0000"/>
                  </a:solidFill>
                  <a:latin typeface="Arial Narrow"/>
                  <a:cs typeface="Arial Narrow"/>
                </a:rPr>
                <a:t>BMD</a:t>
              </a:r>
              <a:r>
                <a:rPr lang="en-US" sz="1400" baseline="-25000" dirty="0">
                  <a:solidFill>
                    <a:srgbClr val="FF0000"/>
                  </a:solidFill>
                  <a:latin typeface="Arial Narrow"/>
                  <a:cs typeface="Arial Narrow"/>
                </a:rPr>
                <a:t>100</a:t>
              </a:r>
              <a:r>
                <a:rPr lang="en-US" sz="1400" dirty="0">
                  <a:solidFill>
                    <a:srgbClr val="FF0000"/>
                  </a:solidFill>
                  <a:latin typeface="Arial Narrow"/>
                  <a:cs typeface="Arial Narrow"/>
                </a:rPr>
                <a:t> = 0.7 ug.mL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60216" y="4602922"/>
              <a:ext cx="16664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 Narrow"/>
                  <a:cs typeface="Arial Narrow"/>
                </a:rPr>
                <a:t>BMD</a:t>
              </a:r>
              <a:r>
                <a:rPr lang="en-US" sz="1400" baseline="-25000" dirty="0">
                  <a:latin typeface="Arial Narrow"/>
                  <a:cs typeface="Arial Narrow"/>
                </a:rPr>
                <a:t>100</a:t>
              </a:r>
              <a:r>
                <a:rPr lang="en-US" sz="1400" dirty="0">
                  <a:latin typeface="Arial Narrow"/>
                  <a:cs typeface="Arial Narrow"/>
                </a:rPr>
                <a:t> = 0.6 ug.m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866358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0B9A92-7982-E2C9-BC1C-A1EB2F34D565}"/>
              </a:ext>
            </a:extLst>
          </p:cNvPr>
          <p:cNvSpPr txBox="1"/>
          <p:nvPr/>
        </p:nvSpPr>
        <p:spPr>
          <a:xfrm>
            <a:off x="0" y="0"/>
            <a:ext cx="9601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Table 2: Data used for the quantitative comparison (Figure S1) of micronucleus dose-response relationships for carbendazim scored manually or by </a:t>
            </a:r>
            <a:r>
              <a:rPr lang="en-GB" sz="16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ImageStream</a:t>
            </a:r>
            <a:r>
              <a:rPr lang="en-GB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 flow-cytometry 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D8387922-818A-55C1-726C-B3311AC468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6944262"/>
              </p:ext>
            </p:extLst>
          </p:nvPr>
        </p:nvGraphicFramePr>
        <p:xfrm>
          <a:off x="-1" y="609600"/>
          <a:ext cx="9601200" cy="747623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752601">
                  <a:extLst>
                    <a:ext uri="{9D8B030D-6E8A-4147-A177-3AD203B41FA5}">
                      <a16:colId xmlns:a16="http://schemas.microsoft.com/office/drawing/2014/main" val="1797151865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311218043"/>
                    </a:ext>
                  </a:extLst>
                </a:gridCol>
                <a:gridCol w="1269999">
                  <a:extLst>
                    <a:ext uri="{9D8B030D-6E8A-4147-A177-3AD203B41FA5}">
                      <a16:colId xmlns:a16="http://schemas.microsoft.com/office/drawing/2014/main" val="917989394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4195773247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012369612"/>
                    </a:ext>
                  </a:extLst>
                </a:gridCol>
                <a:gridCol w="1917701">
                  <a:extLst>
                    <a:ext uri="{9D8B030D-6E8A-4147-A177-3AD203B41FA5}">
                      <a16:colId xmlns:a16="http://schemas.microsoft.com/office/drawing/2014/main" val="285848157"/>
                    </a:ext>
                  </a:extLst>
                </a:gridCol>
                <a:gridCol w="825499">
                  <a:extLst>
                    <a:ext uri="{9D8B030D-6E8A-4147-A177-3AD203B41FA5}">
                      <a16:colId xmlns:a16="http://schemas.microsoft.com/office/drawing/2014/main" val="2405907619"/>
                    </a:ext>
                  </a:extLst>
                </a:gridCol>
              </a:tblGrid>
              <a:tr h="686462"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ose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Method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Mean %MN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Lower Error Bar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Upper Error Bar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28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890313577"/>
                  </a:ext>
                </a:extLst>
              </a:tr>
              <a:tr h="492408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  <a:r>
                        <a:rPr lang="en-GB" sz="2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ua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5811417"/>
                  </a:ext>
                </a:extLst>
              </a:tr>
              <a:tr h="492408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  <a:r>
                        <a:rPr lang="en-GB" sz="2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ua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76289533"/>
                  </a:ext>
                </a:extLst>
              </a:tr>
              <a:tr h="520058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  <a:r>
                        <a:rPr lang="en-GB" sz="2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ua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2887336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  <a:r>
                        <a:rPr lang="en-GB" sz="2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ua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4151353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99488300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61550435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4269144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4202501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06263402"/>
                  </a:ext>
                </a:extLst>
              </a:tr>
              <a:tr h="519313"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endazi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M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25062991"/>
                  </a:ext>
                </a:extLst>
              </a:tr>
              <a:tr h="717703">
                <a:tc gridSpan="7">
                  <a:txBody>
                    <a:bodyPr/>
                    <a:lstStyle/>
                    <a:p>
                      <a:r>
                        <a:rPr lang="en-GB" sz="1800" i="1" baseline="30000" dirty="0"/>
                        <a:t>1</a:t>
                      </a:r>
                      <a:r>
                        <a:rPr lang="en-GB" sz="1800" i="1" baseline="0" dirty="0"/>
                        <a:t>Data obtained from Verma et al. 2018</a:t>
                      </a:r>
                    </a:p>
                    <a:p>
                      <a:r>
                        <a:rPr lang="en-GB" sz="1800" i="1" baseline="0" dirty="0"/>
                        <a:t>Manual – Cytokinesis-block micronucleus</a:t>
                      </a:r>
                    </a:p>
                    <a:p>
                      <a:r>
                        <a:rPr lang="en-GB" sz="1800" i="1" baseline="0" dirty="0"/>
                        <a:t>ISMN – Image Stream micronucleus</a:t>
                      </a:r>
                    </a:p>
                    <a:p>
                      <a:r>
                        <a:rPr lang="en-GB" sz="1800" i="1" baseline="0" dirty="0"/>
                        <a:t>SD – Standard Deviation</a:t>
                      </a:r>
                      <a:endParaRPr lang="en-GB" sz="1800" i="1" baseline="30000" dirty="0"/>
                    </a:p>
                    <a:p>
                      <a:endParaRPr lang="en-GB" sz="2800" i="1" baseline="30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2400" baseline="30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2800" baseline="30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GB" sz="2800" baseline="300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GB" sz="2800" baseline="30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697656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789677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D4865A20-42A2-8772-8C94-6F89EADE49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0646025"/>
              </p:ext>
            </p:extLst>
          </p:nvPr>
        </p:nvGraphicFramePr>
        <p:xfrm>
          <a:off x="0" y="682172"/>
          <a:ext cx="9601200" cy="60350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898073">
                  <a:extLst>
                    <a:ext uri="{9D8B030D-6E8A-4147-A177-3AD203B41FA5}">
                      <a16:colId xmlns:a16="http://schemas.microsoft.com/office/drawing/2014/main" val="1797151865"/>
                    </a:ext>
                  </a:extLst>
                </a:gridCol>
                <a:gridCol w="7703127">
                  <a:extLst>
                    <a:ext uri="{9D8B030D-6E8A-4147-A177-3AD203B41FA5}">
                      <a16:colId xmlns:a16="http://schemas.microsoft.com/office/drawing/2014/main" val="3076833360"/>
                    </a:ext>
                  </a:extLst>
                </a:gridCol>
              </a:tblGrid>
              <a:tr h="1066800">
                <a:tc>
                  <a:txBody>
                    <a:bodyPr/>
                    <a:lstStyle/>
                    <a:p>
                      <a:endParaRPr lang="en-GB" sz="2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800" dirty="0"/>
                        <a:t>Overall MN Mask Function Combination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0313577"/>
                  </a:ext>
                </a:extLst>
              </a:tr>
              <a:tr h="1066800">
                <a:tc>
                  <a:txBody>
                    <a:bodyPr/>
                    <a:lstStyle/>
                    <a:p>
                      <a:r>
                        <a:rPr lang="en-GB" sz="2800" dirty="0"/>
                        <a:t>MN Mask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800" dirty="0"/>
                        <a:t>(Range(Spot(Threshold(M11, Draq5,90)Bright, 3,6,1)5-100,0.4- 1) AND NOT (Range(Dilate(</a:t>
                      </a:r>
                      <a:r>
                        <a:rPr lang="en-GB" sz="2800" dirty="0" err="1"/>
                        <a:t>LevelSet</a:t>
                      </a:r>
                      <a:r>
                        <a:rPr lang="en-GB" sz="2800" dirty="0"/>
                        <a:t>(M11,Draq5,Middle,3)1)100- 5000,0.2-1)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6289533"/>
                  </a:ext>
                </a:extLst>
              </a:tr>
              <a:tr h="1066800">
                <a:tc>
                  <a:txBody>
                    <a:bodyPr/>
                    <a:lstStyle/>
                    <a:p>
                      <a:r>
                        <a:rPr lang="en-GB" sz="2800" dirty="0"/>
                        <a:t>MN Mask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800" dirty="0"/>
                        <a:t>Range ((Threshold (Spot (M11, Draq5, Bright 2,5,2) Draq5,88) AND NOT (Range(</a:t>
                      </a:r>
                      <a:r>
                        <a:rPr lang="en-GB" sz="2800" dirty="0" err="1"/>
                        <a:t>LevelSet</a:t>
                      </a:r>
                      <a:r>
                        <a:rPr lang="en-GB" sz="2800" dirty="0"/>
                        <a:t>(M11,Draq5,middle,5)90-5000,0-1)10-80,0.4-1)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2887336"/>
                  </a:ext>
                </a:extLst>
              </a:tr>
              <a:tr h="1066800">
                <a:tc>
                  <a:txBody>
                    <a:bodyPr/>
                    <a:lstStyle/>
                    <a:p>
                      <a:r>
                        <a:rPr lang="en-GB" sz="2800" dirty="0"/>
                        <a:t>MN Mask 3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2800" dirty="0"/>
                        <a:t>Range ((Threshold (Spot (M11, Draq5, Bright 2,6,2) Draq5,88) AND NOT (Dilate(Morphology(M11, Draq5)1)10-80,0.4-1)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415135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A00BC54-8F03-E296-BCDB-86D10FE4A0FA}"/>
              </a:ext>
            </a:extLst>
          </p:cNvPr>
          <p:cNvSpPr txBox="1"/>
          <p:nvPr/>
        </p:nvSpPr>
        <p:spPr>
          <a:xfrm>
            <a:off x="0" y="97397"/>
            <a:ext cx="9601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Table 3: Summary of the functions used to generate the three MN masks that make up the complete final MN mask. </a:t>
            </a:r>
          </a:p>
        </p:txBody>
      </p:sp>
    </p:spTree>
    <p:extLst>
      <p:ext uri="{BB962C8B-B14F-4D97-AF65-F5344CB8AC3E}">
        <p14:creationId xmlns:p14="http://schemas.microsoft.com/office/powerpoint/2010/main" val="1709954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540</Words>
  <Application>Microsoft Office PowerPoint</Application>
  <PresentationFormat>A3 Paper (297x420 mm)</PresentationFormat>
  <Paragraphs>16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 Narrow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nii Harte</dc:creator>
  <cp:lastModifiedBy>Dannii Harte</cp:lastModifiedBy>
  <cp:revision>2</cp:revision>
  <dcterms:created xsi:type="dcterms:W3CDTF">2024-02-29T20:34:32Z</dcterms:created>
  <dcterms:modified xsi:type="dcterms:W3CDTF">2024-05-20T13:15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a66b2b-af80-48b6-873b-d341d3035cfa_Enabled">
    <vt:lpwstr>true</vt:lpwstr>
  </property>
  <property fmtid="{D5CDD505-2E9C-101B-9397-08002B2CF9AE}" pid="3" name="MSIP_Label_bea66b2b-af80-48b6-873b-d341d3035cfa_SetDate">
    <vt:lpwstr>2024-05-20T07:41:51Z</vt:lpwstr>
  </property>
  <property fmtid="{D5CDD505-2E9C-101B-9397-08002B2CF9AE}" pid="4" name="MSIP_Label_bea66b2b-af80-48b6-873b-d341d3035cfa_Method">
    <vt:lpwstr>Standard</vt:lpwstr>
  </property>
  <property fmtid="{D5CDD505-2E9C-101B-9397-08002B2CF9AE}" pid="5" name="MSIP_Label_bea66b2b-af80-48b6-873b-d341d3035cfa_Name">
    <vt:lpwstr>Proprietary</vt:lpwstr>
  </property>
  <property fmtid="{D5CDD505-2E9C-101B-9397-08002B2CF9AE}" pid="6" name="MSIP_Label_bea66b2b-af80-48b6-873b-d341d3035cfa_SiteId">
    <vt:lpwstr>63982aff-fb6c-4c22-973b-70e4acfb63e6</vt:lpwstr>
  </property>
  <property fmtid="{D5CDD505-2E9C-101B-9397-08002B2CF9AE}" pid="7" name="MSIP_Label_bea66b2b-af80-48b6-873b-d341d3035cfa_ActionId">
    <vt:lpwstr>d9076f4a-e61d-4cab-98c6-1b6a0e219309</vt:lpwstr>
  </property>
  <property fmtid="{D5CDD505-2E9C-101B-9397-08002B2CF9AE}" pid="8" name="MSIP_Label_bea66b2b-af80-48b6-873b-d341d3035cfa_ContentBits">
    <vt:lpwstr>0</vt:lpwstr>
  </property>
</Properties>
</file>